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29CA5C-84D7-4D31-AA30-9BA0CB3156A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11374F-F1DE-4F96-AC0E-12132A3681A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1BA2C3-5F4C-4FAD-9F78-CE431F58C55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786231-C341-44BF-8C89-F29B2BA38F7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91BC60-35E1-4759-B1BC-A881FDC0643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80D8AC-ABFE-4179-9AAB-60CC55217E2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660766-6657-4845-BF2A-9D2567C723D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7B653A-BA85-4E14-8881-C81E6A3F0D0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4781B1-BDE1-4BD2-9144-55793A3A8A3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0288FE-E16C-4620-ACE2-4A010E7175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3E3A64-A14C-4CBB-9D97-1CF0D91F8C7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6179C3-E311-4071-B284-F475FBF04E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DE76746-7C7D-46C4-94AC-EDF64F43A83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3"/>
          <p:cNvSpPr/>
          <p:nvPr/>
        </p:nvSpPr>
        <p:spPr>
          <a:xfrm>
            <a:off x="5334120" y="8610480"/>
            <a:ext cx="1218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 Figure 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テキスト ボックス 31"/>
          <p:cNvSpPr/>
          <p:nvPr/>
        </p:nvSpPr>
        <p:spPr>
          <a:xfrm rot="16200000">
            <a:off x="1010160" y="4093560"/>
            <a:ext cx="1360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WISP-1/S2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直線コネクタ 18"/>
          <p:cNvSpPr/>
          <p:nvPr/>
        </p:nvSpPr>
        <p:spPr>
          <a:xfrm flipH="1" flipV="1">
            <a:off x="2144880" y="5152680"/>
            <a:ext cx="2698560" cy="32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正方形/長方形 32"/>
          <p:cNvSpPr/>
          <p:nvPr/>
        </p:nvSpPr>
        <p:spPr>
          <a:xfrm>
            <a:off x="2262240" y="3900600"/>
            <a:ext cx="293760" cy="125388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5" name="図形グループ 33"/>
          <p:cNvGrpSpPr/>
          <p:nvPr/>
        </p:nvGrpSpPr>
        <p:grpSpPr>
          <a:xfrm>
            <a:off x="2324160" y="3871800"/>
            <a:ext cx="171360" cy="32040"/>
            <a:chOff x="2324160" y="3871800"/>
            <a:chExt cx="171360" cy="32040"/>
          </a:xfrm>
        </p:grpSpPr>
        <p:sp>
          <p:nvSpPr>
            <p:cNvPr id="46" name="直線コネクタ 34"/>
            <p:cNvSpPr/>
            <p:nvPr/>
          </p:nvSpPr>
          <p:spPr>
            <a:xfrm flipH="1">
              <a:off x="2410560" y="3871800"/>
              <a:ext cx="1800" cy="32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直線コネクタ 35"/>
            <p:cNvSpPr/>
            <p:nvPr/>
          </p:nvSpPr>
          <p:spPr>
            <a:xfrm>
              <a:off x="2324160" y="3871800"/>
              <a:ext cx="1713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8" name="直線コネクタ 60"/>
          <p:cNvSpPr/>
          <p:nvPr/>
        </p:nvSpPr>
        <p:spPr>
          <a:xfrm flipH="1">
            <a:off x="2189160" y="3311640"/>
            <a:ext cx="1440" cy="18399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テキスト ボックス 61"/>
          <p:cNvSpPr/>
          <p:nvPr/>
        </p:nvSpPr>
        <p:spPr>
          <a:xfrm>
            <a:off x="1792440" y="4375080"/>
            <a:ext cx="449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テキスト ボックス 64"/>
          <p:cNvSpPr/>
          <p:nvPr/>
        </p:nvSpPr>
        <p:spPr>
          <a:xfrm>
            <a:off x="1911240" y="4981680"/>
            <a:ext cx="304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直線コネクタ 67"/>
          <p:cNvSpPr/>
          <p:nvPr/>
        </p:nvSpPr>
        <p:spPr>
          <a:xfrm flipH="1" flipV="1">
            <a:off x="2141640" y="4527720"/>
            <a:ext cx="475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2" name="図形グループ 72"/>
          <p:cNvGrpSpPr/>
          <p:nvPr/>
        </p:nvGrpSpPr>
        <p:grpSpPr>
          <a:xfrm>
            <a:off x="2759040" y="5011560"/>
            <a:ext cx="171360" cy="68400"/>
            <a:chOff x="2759040" y="5011560"/>
            <a:chExt cx="171360" cy="68400"/>
          </a:xfrm>
        </p:grpSpPr>
        <p:sp>
          <p:nvSpPr>
            <p:cNvPr id="53" name="直線コネクタ 73"/>
            <p:cNvSpPr/>
            <p:nvPr/>
          </p:nvSpPr>
          <p:spPr>
            <a:xfrm flipH="1">
              <a:off x="2845440" y="5011560"/>
              <a:ext cx="1800" cy="684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直線コネクタ 74"/>
            <p:cNvSpPr/>
            <p:nvPr/>
          </p:nvSpPr>
          <p:spPr>
            <a:xfrm>
              <a:off x="2759040" y="5011560"/>
              <a:ext cx="171360" cy="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5" name="正方形/長方形 75"/>
          <p:cNvSpPr/>
          <p:nvPr/>
        </p:nvSpPr>
        <p:spPr>
          <a:xfrm>
            <a:off x="2697120" y="5029200"/>
            <a:ext cx="293760" cy="117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正方形/長方形 76"/>
          <p:cNvSpPr/>
          <p:nvPr/>
        </p:nvSpPr>
        <p:spPr>
          <a:xfrm>
            <a:off x="3138480" y="4248000"/>
            <a:ext cx="293760" cy="8938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7" name="図形グループ 77"/>
          <p:cNvGrpSpPr/>
          <p:nvPr/>
        </p:nvGrpSpPr>
        <p:grpSpPr>
          <a:xfrm>
            <a:off x="3198960" y="4203720"/>
            <a:ext cx="172800" cy="250920"/>
            <a:chOff x="3198960" y="4203720"/>
            <a:chExt cx="172800" cy="250920"/>
          </a:xfrm>
        </p:grpSpPr>
        <p:sp>
          <p:nvSpPr>
            <p:cNvPr id="58" name="直線コネクタ 78"/>
            <p:cNvSpPr/>
            <p:nvPr/>
          </p:nvSpPr>
          <p:spPr>
            <a:xfrm flipH="1">
              <a:off x="3286080" y="4203720"/>
              <a:ext cx="1800" cy="250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直線コネクタ 79"/>
            <p:cNvSpPr/>
            <p:nvPr/>
          </p:nvSpPr>
          <p:spPr>
            <a:xfrm>
              <a:off x="3198960" y="4203720"/>
              <a:ext cx="172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0" name="図形グループ 80"/>
          <p:cNvGrpSpPr/>
          <p:nvPr/>
        </p:nvGrpSpPr>
        <p:grpSpPr>
          <a:xfrm>
            <a:off x="3629160" y="4794120"/>
            <a:ext cx="171360" cy="120960"/>
            <a:chOff x="3629160" y="4794120"/>
            <a:chExt cx="171360" cy="120960"/>
          </a:xfrm>
        </p:grpSpPr>
        <p:sp>
          <p:nvSpPr>
            <p:cNvPr id="61" name="直線コネクタ 81"/>
            <p:cNvSpPr/>
            <p:nvPr/>
          </p:nvSpPr>
          <p:spPr>
            <a:xfrm flipH="1">
              <a:off x="3715560" y="4794120"/>
              <a:ext cx="1800" cy="1209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直線コネクタ 82"/>
            <p:cNvSpPr/>
            <p:nvPr/>
          </p:nvSpPr>
          <p:spPr>
            <a:xfrm>
              <a:off x="3629160" y="4794120"/>
              <a:ext cx="171360" cy="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3" name="正方形/長方形 83"/>
          <p:cNvSpPr/>
          <p:nvPr/>
        </p:nvSpPr>
        <p:spPr>
          <a:xfrm>
            <a:off x="3567240" y="4809960"/>
            <a:ext cx="293400" cy="3477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4" name="図形グループ 80"/>
          <p:cNvGrpSpPr/>
          <p:nvPr/>
        </p:nvGrpSpPr>
        <p:grpSpPr>
          <a:xfrm>
            <a:off x="4073400" y="4440240"/>
            <a:ext cx="171720" cy="301680"/>
            <a:chOff x="4073400" y="4440240"/>
            <a:chExt cx="171720" cy="301680"/>
          </a:xfrm>
        </p:grpSpPr>
        <p:sp>
          <p:nvSpPr>
            <p:cNvPr id="65" name="直線コネクタ 81"/>
            <p:cNvSpPr/>
            <p:nvPr/>
          </p:nvSpPr>
          <p:spPr>
            <a:xfrm flipH="1">
              <a:off x="4159800" y="4440240"/>
              <a:ext cx="1800" cy="301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直線コネクタ 82"/>
            <p:cNvSpPr/>
            <p:nvPr/>
          </p:nvSpPr>
          <p:spPr>
            <a:xfrm>
              <a:off x="4073400" y="4440240"/>
              <a:ext cx="17172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7" name="正方形/長方形 83"/>
          <p:cNvSpPr/>
          <p:nvPr/>
        </p:nvSpPr>
        <p:spPr>
          <a:xfrm>
            <a:off x="4011480" y="4470480"/>
            <a:ext cx="293760" cy="6746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テキスト ボックス 54"/>
          <p:cNvSpPr/>
          <p:nvPr/>
        </p:nvSpPr>
        <p:spPr>
          <a:xfrm>
            <a:off x="2643120" y="4784760"/>
            <a:ext cx="409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**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9" name="図形グループ 80"/>
          <p:cNvGrpSpPr/>
          <p:nvPr/>
        </p:nvGrpSpPr>
        <p:grpSpPr>
          <a:xfrm>
            <a:off x="4503600" y="4898880"/>
            <a:ext cx="171720" cy="86040"/>
            <a:chOff x="4503600" y="4898880"/>
            <a:chExt cx="171720" cy="86040"/>
          </a:xfrm>
        </p:grpSpPr>
        <p:sp>
          <p:nvSpPr>
            <p:cNvPr id="70" name="直線コネクタ 81"/>
            <p:cNvSpPr/>
            <p:nvPr/>
          </p:nvSpPr>
          <p:spPr>
            <a:xfrm flipH="1">
              <a:off x="4590000" y="4898880"/>
              <a:ext cx="1800" cy="86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240" bIns="392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直線コネクタ 82"/>
            <p:cNvSpPr/>
            <p:nvPr/>
          </p:nvSpPr>
          <p:spPr>
            <a:xfrm>
              <a:off x="4503600" y="4898880"/>
              <a:ext cx="171720" cy="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2" name="正方形/長方形 83"/>
          <p:cNvSpPr/>
          <p:nvPr/>
        </p:nvSpPr>
        <p:spPr>
          <a:xfrm>
            <a:off x="4441680" y="4915080"/>
            <a:ext cx="293760" cy="2300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テキスト ボックス 61"/>
          <p:cNvSpPr/>
          <p:nvPr/>
        </p:nvSpPr>
        <p:spPr>
          <a:xfrm>
            <a:off x="1793880" y="3772080"/>
            <a:ext cx="449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直線コネクタ 67"/>
          <p:cNvSpPr/>
          <p:nvPr/>
        </p:nvSpPr>
        <p:spPr>
          <a:xfrm flipH="1" flipV="1">
            <a:off x="2143080" y="3911760"/>
            <a:ext cx="475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テキスト ボックス 61"/>
          <p:cNvSpPr/>
          <p:nvPr/>
        </p:nvSpPr>
        <p:spPr>
          <a:xfrm>
            <a:off x="1798560" y="3168720"/>
            <a:ext cx="449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.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直線コネクタ 67"/>
          <p:cNvSpPr/>
          <p:nvPr/>
        </p:nvSpPr>
        <p:spPr>
          <a:xfrm flipH="1" flipV="1">
            <a:off x="2147400" y="3314880"/>
            <a:ext cx="493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テキスト ボックス 74"/>
          <p:cNvSpPr/>
          <p:nvPr/>
        </p:nvSpPr>
        <p:spPr>
          <a:xfrm>
            <a:off x="2136600" y="5176800"/>
            <a:ext cx="546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F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テキスト ボックス 75"/>
          <p:cNvSpPr/>
          <p:nvPr/>
        </p:nvSpPr>
        <p:spPr>
          <a:xfrm>
            <a:off x="2596680" y="517680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テキスト ボックス 76"/>
          <p:cNvSpPr/>
          <p:nvPr/>
        </p:nvSpPr>
        <p:spPr>
          <a:xfrm>
            <a:off x="3085920" y="5176800"/>
            <a:ext cx="398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テキスト ボックス 77"/>
          <p:cNvSpPr/>
          <p:nvPr/>
        </p:nvSpPr>
        <p:spPr>
          <a:xfrm>
            <a:off x="3514680" y="5176800"/>
            <a:ext cx="398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テキスト ボックス 78"/>
          <p:cNvSpPr/>
          <p:nvPr/>
        </p:nvSpPr>
        <p:spPr>
          <a:xfrm>
            <a:off x="3958920" y="5176800"/>
            <a:ext cx="398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テキスト ボックス 79"/>
          <p:cNvSpPr/>
          <p:nvPr/>
        </p:nvSpPr>
        <p:spPr>
          <a:xfrm>
            <a:off x="4341240" y="517680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テキスト ボックス 54"/>
          <p:cNvSpPr/>
          <p:nvPr/>
        </p:nvSpPr>
        <p:spPr>
          <a:xfrm>
            <a:off x="3084480" y="3962520"/>
            <a:ext cx="409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**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テキスト ボックス 54"/>
          <p:cNvSpPr/>
          <p:nvPr/>
        </p:nvSpPr>
        <p:spPr>
          <a:xfrm>
            <a:off x="3508200" y="4565520"/>
            <a:ext cx="409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**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テキスト ボックス 54"/>
          <p:cNvSpPr/>
          <p:nvPr/>
        </p:nvSpPr>
        <p:spPr>
          <a:xfrm>
            <a:off x="3951360" y="4194000"/>
            <a:ext cx="409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**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テキスト ボックス 54"/>
          <p:cNvSpPr/>
          <p:nvPr/>
        </p:nvSpPr>
        <p:spPr>
          <a:xfrm>
            <a:off x="4390920" y="4676760"/>
            <a:ext cx="409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**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テキスト ボックス 103"/>
          <p:cNvSpPr/>
          <p:nvPr/>
        </p:nvSpPr>
        <p:spPr>
          <a:xfrm>
            <a:off x="3016440" y="3106800"/>
            <a:ext cx="880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600" spc="-1" strike="noStrike">
                <a:solidFill>
                  <a:srgbClr val="000000"/>
                </a:solidFill>
                <a:latin typeface="Arial"/>
              </a:rPr>
              <a:t>WISP-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1031760" y="6019920"/>
            <a:ext cx="4953240" cy="192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MS Mincho"/>
              </a:rPr>
              <a:t>S3. Efficacy of shRNA to WISP-1.  Five different constructs encoding shRNA to WISP-1 previously packaged into lentivirus were transduced into hBMSC  and relative levels o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MS Mincho"/>
              </a:rPr>
              <a:t>WISP-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MS Mincho"/>
              </a:rPr>
              <a:t> mRNA measured by real-time PCR. ***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MS Mincho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MS Mincho"/>
              </a:rPr>
              <a:t>&lt;0.001 vs. GFP control. All shRNA constructs to WISP-1 showed significant reduction from control with B10 being most effective in knocking down steady state levels of WISP-1 mRNA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99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2-05T07:46:00Z</dcterms:created>
  <dc:creator>Mitsuaki Ono</dc:creator>
  <dc:description/>
  <dc:language>en-US</dc:language>
  <cp:lastModifiedBy>Marian Young</cp:lastModifiedBy>
  <cp:lastPrinted>2010-02-04T00:54:04Z</cp:lastPrinted>
  <dcterms:modified xsi:type="dcterms:W3CDTF">2010-06-15T19:24:08Z</dcterms:modified>
  <cp:revision>399</cp:revision>
  <dc:subject/>
  <dc:title>PowerPoint Presentation</dc:title>
</cp:coreProperties>
</file>